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-120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94E25B-553A-48C8-BB3D-2F34A13CE9DF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DBC022-6FD5-434E-98E4-62B3BDCE5D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DBC022-6FD5-434E-98E4-62B3BDCE5D72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0A052-BFE3-4585-B850-88DC4EEC9694}" type="datetimeFigureOut">
              <a:rPr lang="ko-KR" altLang="en-US" smtClean="0"/>
              <a:pPr/>
              <a:t>2014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CFD47-3CB4-4FF5-AB31-9C3F5E651FB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928662" y="1071546"/>
            <a:ext cx="7000924" cy="44736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142844" y="5929330"/>
            <a:ext cx="88582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S1. 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Population stratification of </a:t>
            </a:r>
            <a:r>
              <a:rPr lang="en-US" altLang="ko-KR" dirty="0" err="1" smtClean="0">
                <a:latin typeface="Arial" pitchFamily="34" charset="0"/>
                <a:cs typeface="Arial" pitchFamily="34" charset="0"/>
              </a:rPr>
              <a:t>Ansung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US" altLang="ko-KR" dirty="0" err="1" smtClean="0">
                <a:latin typeface="Arial" pitchFamily="34" charset="0"/>
                <a:cs typeface="Arial" pitchFamily="34" charset="0"/>
              </a:rPr>
              <a:t>Ansan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. The PCA analysis by using the </a:t>
            </a:r>
            <a:r>
              <a:rPr lang="en-US" altLang="ko-KR" dirty="0" err="1" smtClean="0">
                <a:latin typeface="Arial" pitchFamily="34" charset="0"/>
                <a:cs typeface="Arial" pitchFamily="34" charset="0"/>
              </a:rPr>
              <a:t>Affymetrix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 5.0 SNP array were conducted by EIGENSTAT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43240" y="5500702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Principal Component 1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-565465" y="3208615"/>
            <a:ext cx="27860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Principal Component 2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타원 7"/>
          <p:cNvSpPr/>
          <p:nvPr/>
        </p:nvSpPr>
        <p:spPr>
          <a:xfrm>
            <a:off x="7715272" y="1500174"/>
            <a:ext cx="71438" cy="71438"/>
          </a:xfrm>
          <a:prstGeom prst="ellipse">
            <a:avLst/>
          </a:prstGeom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타원 8"/>
          <p:cNvSpPr/>
          <p:nvPr/>
        </p:nvSpPr>
        <p:spPr>
          <a:xfrm>
            <a:off x="7715272" y="1785926"/>
            <a:ext cx="71438" cy="71438"/>
          </a:xfrm>
          <a:prstGeom prst="ellipse">
            <a:avLst/>
          </a:prstGeom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TextBox 9"/>
          <p:cNvSpPr txBox="1"/>
          <p:nvPr/>
        </p:nvSpPr>
        <p:spPr>
          <a:xfrm>
            <a:off x="7786710" y="128586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err="1" smtClean="0"/>
              <a:t>Ansung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786710" y="164305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err="1" smtClean="0"/>
              <a:t>Ansan</a:t>
            </a:r>
            <a:endParaRPr lang="ko-KR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3</Words>
  <Application>Microsoft Office PowerPoint</Application>
  <PresentationFormat>화면 슬라이드 쇼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홍경원</dc:creator>
  <cp:lastModifiedBy>홍경원</cp:lastModifiedBy>
  <cp:revision>2</cp:revision>
  <dcterms:created xsi:type="dcterms:W3CDTF">2014-05-16T00:22:39Z</dcterms:created>
  <dcterms:modified xsi:type="dcterms:W3CDTF">2014-11-10T00:52:00Z</dcterms:modified>
</cp:coreProperties>
</file>